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D8DC84-1511-4F1F-B933-982441CC78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50FEDEF-75DD-4ED2-A914-3A079173E9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6648C8-AD0F-4350-967D-EA44182D6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8616AF-B01D-41CE-9B7E-B0B440089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B6D7AB-F72C-4A45-8B4F-2C2864793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5278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5B9E42-E0B4-4C65-B20D-B9C1D4D7F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4C7E39-2BB9-4418-95F6-FD8A8FD1F7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E609AD-2C78-4DB2-AD41-9A918BB71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1B4017-5F8A-4F81-B900-5C78A2471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B5E9F4-2944-466D-ACA5-14675318C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03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9490124-2430-4020-B25C-48AD163BE8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FEFBD5E-856D-45AD-AB3F-E341A42130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6339CF-B749-45DB-B0E8-7D6937C86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D8D110-FD8A-4E5E-8ABF-CBBE86EF6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399199-E406-4169-8F41-419FB409E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1451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3657C6-A005-43D2-B289-5E813134A1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EEBE5B-989D-4ADF-AEB7-E9439D3B85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027E44-EA7F-4491-9E54-EA263F141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AA77F3-BA64-4346-B0B1-DEB087AEC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15F50A-FC5C-45AE-A1DC-E0F32274F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429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719BBA-CBA5-433F-A853-741490137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E02565-C1FB-45CF-8CD7-2A17657D47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59238A-C770-4119-A6A9-D0878A5CD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C194A0-AEEB-4AD2-A83D-A92C7E919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52FF19-A576-4D31-955D-C4C33F7A1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8454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9823F6-24DE-443E-A32F-A250CE9CEF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82F942-FCB5-4041-A9EE-9F691257E8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D312260-97A8-4512-86E2-2C446769CD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331B7C8-55A6-4580-ABC9-334FB786A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EA1478-8FA8-4DC3-9553-8E1D7E091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CAB0640-0381-4C35-A4EB-21DB3D7AD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9755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8D9FC1-2699-45BF-BE73-1D507F9B76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03B9D0-0117-459A-B0A3-EF28AF5AA6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F6267A3-1F4D-475E-86F3-21C21DEEA4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550FB1D-8603-4A63-85A7-934D889C94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EA0271-35EB-44EA-A9D7-E780E31A71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D6E1299-4E47-42DE-8FFD-FA4FF25E1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F2CD125-9FF8-4B7B-8309-8447BFD12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8336EB-2E7C-486C-AE30-DC834E464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77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6AFAF4-FAC9-4725-9370-2E42F175B3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EDED924-D125-4271-81E9-2A270B1CC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6324337-0A76-4F92-AD4A-4BC04FE98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B99072E-CDA7-403B-AA98-1E86C2F32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516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BB672A6-7E53-404F-A6CD-1CCE5DB65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712513B-4F20-419D-92CF-F93739355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647E8B0-B58A-479E-8095-287F24FA4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8082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CA0229-7752-4621-AD70-676FB03107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0D5B496-16AC-4D32-90DD-B86178067D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0C2963A-4C1C-4ACA-AF9B-5F7189853E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0B7328-3C70-4144-A033-0756282F9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279D286-97B4-4D71-A877-856700D35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AA22D4-2DD7-44CB-A0DA-27D41B60A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0923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987275-EDBE-4ED5-BEA0-266F94B5C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4CE0AE6-BE58-455E-A25D-317514B4EB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DAC5CA-097C-4738-B755-8D90B603C6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A4AC07C-1606-4FFC-AFF4-07C5C921E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6AE86F3-A975-4AF2-85F1-001C5265D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D260343-5D6E-44DE-9F45-3E36EB92E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6966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7336B5A-A404-40A4-986A-B3240B697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5FBEA37-018D-4732-8E7D-037E03D3D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482C64-B6E1-4690-9EA1-0DFA3B84A2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4418D-8224-4D36-89B2-F82B1A4B5070}" type="datetimeFigureOut">
              <a:rPr lang="zh-CN" altLang="en-US" smtClean="0"/>
              <a:t>2020/6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CB65A0-CC00-4BFE-81F3-2E53487D4D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77E7B3-FA84-4A8D-A269-578AB3785D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F8CF2-97F1-41EC-8EB1-F81F5D609C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8574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3" Type="http://schemas.microsoft.com/office/2007/relationships/hdphoto" Target="../media/hdphoto1.wdp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openxmlformats.org/officeDocument/2006/relationships/image" Target="../media/image3.tif"/><Relationship Id="rId15" Type="http://schemas.openxmlformats.org/officeDocument/2006/relationships/image" Target="../media/image9.tif"/><Relationship Id="rId10" Type="http://schemas.openxmlformats.org/officeDocument/2006/relationships/image" Target="../media/image6.png"/><Relationship Id="rId4" Type="http://schemas.openxmlformats.org/officeDocument/2006/relationships/image" Target="../media/image2.tif"/><Relationship Id="rId9" Type="http://schemas.microsoft.com/office/2007/relationships/hdphoto" Target="../media/hdphoto3.wdp"/><Relationship Id="rId14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46F2D8EB-7977-4FC6-B60F-6BC2DED030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829" t="33638" r="26270" b="62230"/>
          <a:stretch/>
        </p:blipFill>
        <p:spPr>
          <a:xfrm>
            <a:off x="7410056" y="2325086"/>
            <a:ext cx="4254284" cy="3847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EEFD7A1-B8BE-46E8-B611-232C2EFB119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9" t="48659" r="15019" b="44402"/>
          <a:stretch/>
        </p:blipFill>
        <p:spPr>
          <a:xfrm>
            <a:off x="7410055" y="765220"/>
            <a:ext cx="4254287" cy="2971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69573A84-8796-4D06-BD04-933B06FF72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01" t="45296" r="-29182" b="43240"/>
          <a:stretch/>
        </p:blipFill>
        <p:spPr>
          <a:xfrm>
            <a:off x="7410055" y="1553035"/>
            <a:ext cx="4254286" cy="3271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B45BFAE-4A0E-490F-B215-BF00074AF39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9" t="28666" r="34147" b="58647"/>
          <a:stretch/>
        </p:blipFill>
        <p:spPr>
          <a:xfrm flipH="1">
            <a:off x="7410053" y="332231"/>
            <a:ext cx="4254289" cy="432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CD85CAE7-AF6A-4791-9A3D-6248811E3F4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5849" t="47969" r="70372" b="48219"/>
          <a:stretch/>
        </p:blipFill>
        <p:spPr>
          <a:xfrm flipH="1" flipV="1">
            <a:off x="7410055" y="1953681"/>
            <a:ext cx="4254285" cy="3264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4A59E2A-6CCA-48E8-93CF-302E9A477E1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94" t="47034" r="45565" b="45194"/>
          <a:stretch/>
        </p:blipFill>
        <p:spPr>
          <a:xfrm>
            <a:off x="7410054" y="1137999"/>
            <a:ext cx="4254287" cy="3793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BA3F9213-FA86-4BCC-BA7A-4CC4A21BD24E}"/>
              </a:ext>
            </a:extLst>
          </p:cNvPr>
          <p:cNvSpPr txBox="1"/>
          <p:nvPr/>
        </p:nvSpPr>
        <p:spPr>
          <a:xfrm>
            <a:off x="6748416" y="2415827"/>
            <a:ext cx="582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ctin</a:t>
            </a:r>
            <a:endParaRPr lang="zh-CN" altLang="en-US" sz="12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8A1E8EC-7C3A-4997-BD30-61BEEF085F5A}"/>
              </a:ext>
            </a:extLst>
          </p:cNvPr>
          <p:cNvSpPr txBox="1"/>
          <p:nvPr/>
        </p:nvSpPr>
        <p:spPr>
          <a:xfrm>
            <a:off x="6340822" y="1582066"/>
            <a:ext cx="1166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Pro-caspase1</a:t>
            </a:r>
            <a:endParaRPr lang="zh-CN" altLang="en-US" sz="12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3AFBD03-0DD7-4CF0-B4F9-94D5692AC162}"/>
              </a:ext>
            </a:extLst>
          </p:cNvPr>
          <p:cNvSpPr txBox="1"/>
          <p:nvPr/>
        </p:nvSpPr>
        <p:spPr>
          <a:xfrm>
            <a:off x="6616721" y="1203161"/>
            <a:ext cx="842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aspase1</a:t>
            </a:r>
            <a:endParaRPr lang="zh-CN" altLang="en-US" sz="12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AE6E5E0-F688-4134-9117-E285D5278317}"/>
              </a:ext>
            </a:extLst>
          </p:cNvPr>
          <p:cNvSpPr txBox="1"/>
          <p:nvPr/>
        </p:nvSpPr>
        <p:spPr>
          <a:xfrm>
            <a:off x="6535567" y="828959"/>
            <a:ext cx="9718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GSDMD FL</a:t>
            </a:r>
            <a:endParaRPr lang="zh-CN" altLang="en-US" sz="1200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3F0D15D-A4EE-422F-9011-3C7A9E387902}"/>
              </a:ext>
            </a:extLst>
          </p:cNvPr>
          <p:cNvSpPr txBox="1"/>
          <p:nvPr/>
        </p:nvSpPr>
        <p:spPr>
          <a:xfrm>
            <a:off x="6568051" y="427804"/>
            <a:ext cx="9718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GSDMD N</a:t>
            </a:r>
            <a:endParaRPr lang="zh-CN" altLang="en-US" sz="12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CB8296D-78E3-4E32-882C-F833EF944425}"/>
              </a:ext>
            </a:extLst>
          </p:cNvPr>
          <p:cNvSpPr txBox="1"/>
          <p:nvPr/>
        </p:nvSpPr>
        <p:spPr>
          <a:xfrm>
            <a:off x="6617036" y="2717454"/>
            <a:ext cx="8235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OVX</a:t>
            </a:r>
          </a:p>
          <a:p>
            <a:pPr algn="ctr"/>
            <a:r>
              <a:rPr lang="en-US" altLang="zh-CN" sz="1200" b="1" dirty="0"/>
              <a:t>LPS</a:t>
            </a:r>
          </a:p>
          <a:p>
            <a:pPr algn="ctr"/>
            <a:r>
              <a:rPr lang="en-US" altLang="zh-CN" sz="1200" b="1" dirty="0"/>
              <a:t>Estrogen</a:t>
            </a:r>
            <a:endParaRPr lang="zh-CN" altLang="en-US" sz="12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3366419-6C74-483E-AD96-62F9B46390AC}"/>
              </a:ext>
            </a:extLst>
          </p:cNvPr>
          <p:cNvSpPr txBox="1"/>
          <p:nvPr/>
        </p:nvSpPr>
        <p:spPr>
          <a:xfrm>
            <a:off x="7484668" y="2725073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－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8B49F01-4E68-4BED-865E-A2E014ABEDC5}"/>
              </a:ext>
            </a:extLst>
          </p:cNvPr>
          <p:cNvSpPr txBox="1"/>
          <p:nvPr/>
        </p:nvSpPr>
        <p:spPr>
          <a:xfrm>
            <a:off x="8053426" y="2725074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－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4954965-373D-443E-AB00-C19591012C5E}"/>
              </a:ext>
            </a:extLst>
          </p:cNvPr>
          <p:cNvSpPr txBox="1"/>
          <p:nvPr/>
        </p:nvSpPr>
        <p:spPr>
          <a:xfrm>
            <a:off x="8586827" y="2725074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＋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26DEC80-DB7F-4658-9330-0410E6FF4517}"/>
              </a:ext>
            </a:extLst>
          </p:cNvPr>
          <p:cNvSpPr txBox="1"/>
          <p:nvPr/>
        </p:nvSpPr>
        <p:spPr>
          <a:xfrm>
            <a:off x="6702738" y="2017996"/>
            <a:ext cx="6699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NLRP3</a:t>
            </a:r>
            <a:endParaRPr lang="zh-CN" altLang="en-US" sz="1200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CD7D897-5532-4EAA-8BE7-DB4F4004AF95}"/>
              </a:ext>
            </a:extLst>
          </p:cNvPr>
          <p:cNvSpPr txBox="1"/>
          <p:nvPr/>
        </p:nvSpPr>
        <p:spPr>
          <a:xfrm>
            <a:off x="9080973" y="2709833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＋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  <a:p>
            <a:pPr algn="ctr"/>
            <a:r>
              <a:rPr lang="en-US" altLang="zh-CN" sz="1200" b="1" dirty="0"/>
              <a:t>+</a:t>
            </a: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7FDCD69F-6B98-4FF5-8ABA-E3D554BD56C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316" t="68425" r="36657" b="30288"/>
          <a:stretch/>
        </p:blipFill>
        <p:spPr>
          <a:xfrm>
            <a:off x="7458751" y="5562902"/>
            <a:ext cx="4675828" cy="3141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158C944A-7873-4A7E-B8A3-08525CCC2123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438" t="58377" r="21778" b="34160"/>
          <a:stretch/>
        </p:blipFill>
        <p:spPr>
          <a:xfrm flipH="1">
            <a:off x="7458753" y="4014875"/>
            <a:ext cx="4604804" cy="3303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3AA774E4-58BB-48D7-A1D5-2374210062AF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54" t="48432" r="22827" b="44022"/>
          <a:stretch/>
        </p:blipFill>
        <p:spPr>
          <a:xfrm>
            <a:off x="7458752" y="5173553"/>
            <a:ext cx="4775929" cy="3838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15D65D99-B175-45A8-913F-985FEB0EDDF0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7" t="69732" r="10448" b="21464"/>
          <a:stretch/>
        </p:blipFill>
        <p:spPr>
          <a:xfrm>
            <a:off x="6186541" y="4717158"/>
            <a:ext cx="5877016" cy="4200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CCA89FB0-B5EF-47FF-B87D-3B6234ABA017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-96425" b="7227"/>
          <a:stretch/>
        </p:blipFill>
        <p:spPr>
          <a:xfrm>
            <a:off x="7458752" y="4400980"/>
            <a:ext cx="4604804" cy="3303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AEB6E0A1-E89B-4000-A7F9-6C7C895C22B7}"/>
              </a:ext>
            </a:extLst>
          </p:cNvPr>
          <p:cNvSpPr txBox="1"/>
          <p:nvPr/>
        </p:nvSpPr>
        <p:spPr>
          <a:xfrm>
            <a:off x="6861145" y="5600100"/>
            <a:ext cx="582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ctin</a:t>
            </a:r>
            <a:endParaRPr lang="zh-CN" altLang="en-US" sz="1200" b="1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A31891B-9FAB-47B9-BDEA-F8AA3D3D2E4D}"/>
              </a:ext>
            </a:extLst>
          </p:cNvPr>
          <p:cNvSpPr txBox="1"/>
          <p:nvPr/>
        </p:nvSpPr>
        <p:spPr>
          <a:xfrm>
            <a:off x="6408482" y="5230144"/>
            <a:ext cx="1166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Pro-caspase1</a:t>
            </a:r>
            <a:endParaRPr lang="zh-CN" altLang="en-US" sz="1200" b="1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10F568EF-F72B-431B-8A0F-D4D9BAE42A55}"/>
              </a:ext>
            </a:extLst>
          </p:cNvPr>
          <p:cNvSpPr txBox="1"/>
          <p:nvPr/>
        </p:nvSpPr>
        <p:spPr>
          <a:xfrm>
            <a:off x="6632966" y="4840187"/>
            <a:ext cx="842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aspase1</a:t>
            </a:r>
            <a:endParaRPr lang="zh-CN" altLang="en-US" sz="1200" b="1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6282C4FD-AAA5-4A14-A057-46F6570C1BC3}"/>
              </a:ext>
            </a:extLst>
          </p:cNvPr>
          <p:cNvSpPr txBox="1"/>
          <p:nvPr/>
        </p:nvSpPr>
        <p:spPr>
          <a:xfrm>
            <a:off x="6603227" y="4487681"/>
            <a:ext cx="9718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GSDMD FL</a:t>
            </a:r>
            <a:endParaRPr lang="zh-CN" altLang="en-US" sz="1200" b="1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0B3697C3-9CB2-4062-A262-E18F8B8DD8BA}"/>
              </a:ext>
            </a:extLst>
          </p:cNvPr>
          <p:cNvSpPr txBox="1"/>
          <p:nvPr/>
        </p:nvSpPr>
        <p:spPr>
          <a:xfrm>
            <a:off x="6624195" y="4107274"/>
            <a:ext cx="9718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GSDMD N</a:t>
            </a:r>
            <a:endParaRPr lang="zh-CN" altLang="en-US" sz="1200" b="1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3AD3DEE-9B30-424F-8993-B86432374D8D}"/>
              </a:ext>
            </a:extLst>
          </p:cNvPr>
          <p:cNvSpPr txBox="1"/>
          <p:nvPr/>
        </p:nvSpPr>
        <p:spPr>
          <a:xfrm>
            <a:off x="6736987" y="5963540"/>
            <a:ext cx="7734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OVX</a:t>
            </a:r>
          </a:p>
          <a:p>
            <a:pPr algn="ctr"/>
            <a:r>
              <a:rPr lang="en-US" altLang="zh-CN" sz="1200" b="1" dirty="0"/>
              <a:t>LPS</a:t>
            </a:r>
          </a:p>
          <a:p>
            <a:pPr algn="ctr"/>
            <a:r>
              <a:rPr lang="en-US" altLang="zh-CN" sz="1200" b="1" dirty="0"/>
              <a:t>MCC950</a:t>
            </a:r>
            <a:endParaRPr lang="zh-CN" altLang="en-US" sz="1200" b="1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E79A6DB-6810-453A-8D58-43D98299A004}"/>
              </a:ext>
            </a:extLst>
          </p:cNvPr>
          <p:cNvSpPr txBox="1"/>
          <p:nvPr/>
        </p:nvSpPr>
        <p:spPr>
          <a:xfrm>
            <a:off x="7506960" y="5958089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－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2573451-03D1-458F-BF3B-D63602ABA2EF}"/>
              </a:ext>
            </a:extLst>
          </p:cNvPr>
          <p:cNvSpPr txBox="1"/>
          <p:nvPr/>
        </p:nvSpPr>
        <p:spPr>
          <a:xfrm>
            <a:off x="8085268" y="5948300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－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FADAB82-82A4-45F9-9378-0328C1CC1750}"/>
              </a:ext>
            </a:extLst>
          </p:cNvPr>
          <p:cNvSpPr txBox="1"/>
          <p:nvPr/>
        </p:nvSpPr>
        <p:spPr>
          <a:xfrm>
            <a:off x="8673939" y="5958090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＋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－</a:t>
            </a:r>
            <a:endParaRPr lang="en-US" altLang="zh-CN" sz="1200" b="1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7B7ED37-1058-4A8F-90A3-942D82AA4091}"/>
              </a:ext>
            </a:extLst>
          </p:cNvPr>
          <p:cNvSpPr txBox="1"/>
          <p:nvPr/>
        </p:nvSpPr>
        <p:spPr>
          <a:xfrm>
            <a:off x="9241884" y="5946130"/>
            <a:ext cx="533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200" b="1" dirty="0"/>
              <a:t>＋       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  <a:p>
            <a:pPr algn="ctr"/>
            <a:r>
              <a:rPr lang="zh-CN" altLang="en-US" sz="1200" b="1" dirty="0"/>
              <a:t>＋</a:t>
            </a:r>
            <a:endParaRPr lang="en-US" altLang="zh-CN" sz="1200" b="1" dirty="0"/>
          </a:p>
        </p:txBody>
      </p:sp>
    </p:spTree>
    <p:extLst>
      <p:ext uri="{BB962C8B-B14F-4D97-AF65-F5344CB8AC3E}">
        <p14:creationId xmlns:p14="http://schemas.microsoft.com/office/powerpoint/2010/main" val="3145645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5</Words>
  <Application>Microsoft Office PowerPoint</Application>
  <PresentationFormat>宽屏</PresentationFormat>
  <Paragraphs>4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贾 庆安</dc:creator>
  <cp:lastModifiedBy>贾 庆安</cp:lastModifiedBy>
  <cp:revision>1</cp:revision>
  <dcterms:created xsi:type="dcterms:W3CDTF">2020-06-08T13:40:20Z</dcterms:created>
  <dcterms:modified xsi:type="dcterms:W3CDTF">2020-06-08T13:41:20Z</dcterms:modified>
</cp:coreProperties>
</file>